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04" d="100"/>
          <a:sy n="104" d="100"/>
        </p:scale>
        <p:origin x="232" y="5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5B90C5-794C-46B2-95E8-F089853BC9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5F6EEB-35D4-57A1-6C49-A2D99DA18B3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47017B-3591-1265-522C-62828E539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5ADC7-CAD0-1E4A-0B95-1BDA3CE5A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95E92A-A7A6-DE70-90B6-C3C0E422B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093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4A74C4-E04A-414B-CADC-A268EF5850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CF0329-6CF1-F8D0-19E6-84CE4E355B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10C1C8-351B-6748-EC7A-9E15680D4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2375DA-2DAE-55F7-70F8-DFA75F104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18AD72-B688-CDA2-B76D-D59149C0A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300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18A6EB-F35A-A84A-4CB8-3124AC3D9C1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7FF6E-0591-CAA5-A0D6-681BAF52FB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49063F-082D-9CBF-48CB-05B5E6035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9F1FEF-6201-C9D3-6A77-70976440FC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DFA9B-1CD8-D3A1-100A-8DB0C1BA5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65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221F6-232C-E2DE-6C0D-414413562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FA0904-1705-581E-777A-B4053DE3D7E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19FBE6-CE7C-86F6-52FD-0DF52B6B3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C20109-8F1A-C81F-50FF-DC78635E0C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EE9C2F-1273-C74F-40A7-39289B787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7910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7B5AF-4EBA-49AF-CBF5-0D391B067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69D4F2-555E-98DB-67D6-2F744BD2DC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FA484C-BC01-2EAF-8FE1-AB233FD45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6DCB1F-0705-85CB-95CB-BF94990430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BB4A8C-E065-4063-3182-4A30E845A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884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00B69-0936-1769-653A-ADB40D3C69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048630-D7A9-4C6C-175E-648AA02439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C48FC6-4B65-885C-6A31-15169809B2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628A4F-873C-EDB0-9A8A-F36D321FC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062C2B-9303-DF2F-1A00-398716FF7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CD0855-8308-8719-AAE9-7B2565A88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545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16F5D-2C82-0834-C3C2-7D72C87D18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55F8E9-DC76-3C9E-FD6F-B6B156F6A3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C1317C-D5C7-8FE2-D599-104185AB76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422384-0737-325E-CABE-59B8ED5486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2AFC6E-2A77-7CE7-CC74-D5C2CEAABF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79720C-5E52-CB4A-7CAC-401485417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2462F93-2593-5638-A776-D28B5CB60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663528-CF3E-100E-3E93-85CBFCB1B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744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BCF83-9D0B-FE56-C695-36603EE60F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7D7B084-4156-FAEF-A726-0F7A73D6A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1FC511-14BC-5CA9-B2EB-71EA58B9E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FEDEF6D-D7FE-6124-4D92-DC6B594FF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0105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A9866E-7CFD-7A47-3690-FCE9F5023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3EB462-A19E-A086-D22A-C191362D5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81C4B0-6E37-1B6F-CFC8-F595456F6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063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AAEF68-09E2-7D0D-11EB-E121D42DE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F90F36-BB9B-63F0-D83A-C18DFC74B4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F54B44-A80A-48D2-A42B-A442843E2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DFB680-BB11-D276-16B5-84519FBBEC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DD2A3A-C48B-25C3-31A6-236B78D55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B7D1E3-EAD3-C6FE-6AE9-A1CD351B8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6472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4ECCE9-E09E-B892-3DC3-243F0BD02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8FC611-6F15-B9DF-CDCA-52C390973C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4C4F1F-A949-FBD5-30DC-35250FE233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B03232-A84B-F0D0-4EC6-DAA5DFC29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B43D31-7227-BE64-280E-EA30E2839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4EA5C9-EB1B-DF40-3370-93CEEB5FA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73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C625D59-D742-B4BC-4F83-D78D4D88A4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52AE26-052B-E28C-6464-E0FC80ACA3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AA5FF8-BB90-D043-0EBA-71474C8D9C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186D7D3-59CC-904B-80E2-1617CD8D39BA}" type="datetimeFigureOut">
              <a:rPr lang="en-US" smtClean="0"/>
              <a:t>10/2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00F49F-FC21-DDB9-77C8-FD14E08C8E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232070-7CF7-674F-D749-D9A986C7BB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4A67AA-3557-A844-9ECC-74D6E72C4A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9931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15">
            <a:extLst>
              <a:ext uri="{FF2B5EF4-FFF2-40B4-BE49-F238E27FC236}">
                <a16:creationId xmlns:a16="http://schemas.microsoft.com/office/drawing/2014/main" id="{5CC958A4-F9E1-1FF7-01D4-A8C6F5AD8C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05223636"/>
              </p:ext>
            </p:extLst>
          </p:nvPr>
        </p:nvGraphicFramePr>
        <p:xfrm>
          <a:off x="2331580" y="624840"/>
          <a:ext cx="7528839" cy="5608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57552">
                  <a:extLst>
                    <a:ext uri="{9D8B030D-6E8A-4147-A177-3AD203B41FA5}">
                      <a16:colId xmlns:a16="http://schemas.microsoft.com/office/drawing/2014/main" val="3918652170"/>
                    </a:ext>
                  </a:extLst>
                </a:gridCol>
                <a:gridCol w="1183946">
                  <a:extLst>
                    <a:ext uri="{9D8B030D-6E8A-4147-A177-3AD203B41FA5}">
                      <a16:colId xmlns:a16="http://schemas.microsoft.com/office/drawing/2014/main" val="2224589020"/>
                    </a:ext>
                  </a:extLst>
                </a:gridCol>
                <a:gridCol w="1255256">
                  <a:extLst>
                    <a:ext uri="{9D8B030D-6E8A-4147-A177-3AD203B41FA5}">
                      <a16:colId xmlns:a16="http://schemas.microsoft.com/office/drawing/2014/main" val="812771144"/>
                    </a:ext>
                  </a:extLst>
                </a:gridCol>
                <a:gridCol w="1738739">
                  <a:extLst>
                    <a:ext uri="{9D8B030D-6E8A-4147-A177-3AD203B41FA5}">
                      <a16:colId xmlns:a16="http://schemas.microsoft.com/office/drawing/2014/main" val="2964992945"/>
                    </a:ext>
                  </a:extLst>
                </a:gridCol>
                <a:gridCol w="1093346">
                  <a:extLst>
                    <a:ext uri="{9D8B030D-6E8A-4147-A177-3AD203B41FA5}">
                      <a16:colId xmlns:a16="http://schemas.microsoft.com/office/drawing/2014/main" val="108155461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Bristol Stool </a:t>
                      </a:r>
                    </a:p>
                    <a:p>
                      <a:pPr algn="ctr"/>
                      <a:r>
                        <a:rPr lang="en-US" sz="2000" dirty="0"/>
                        <a:t>Scal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Upro</a:t>
                      </a:r>
                    </a:p>
                    <a:p>
                      <a:pPr algn="ctr"/>
                      <a:r>
                        <a:rPr lang="en-US" sz="2000" dirty="0"/>
                        <a:t>(n, 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Placebo</a:t>
                      </a:r>
                    </a:p>
                    <a:p>
                      <a:pPr algn="ctr"/>
                      <a:r>
                        <a:rPr lang="en-US" sz="2000" dirty="0"/>
                        <a:t>(n, 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OR </a:t>
                      </a:r>
                    </a:p>
                    <a:p>
                      <a:pPr algn="ctr"/>
                      <a:r>
                        <a:rPr lang="en-US" sz="2000" dirty="0"/>
                        <a:t>(95% CI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31167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1, severe constipa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2, 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0, 3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0.51</a:t>
                      </a:r>
                    </a:p>
                    <a:p>
                      <a:pPr algn="ctr"/>
                      <a:r>
                        <a:rPr lang="en-US" sz="2000" dirty="0"/>
                        <a:t>(0.12, 2.2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0.5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9226808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2, mild constipat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8, 1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7, 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u="none" dirty="0"/>
                        <a:t>0.022</a:t>
                      </a:r>
                    </a:p>
                    <a:p>
                      <a:pPr algn="ctr"/>
                      <a:r>
                        <a:rPr lang="en-US" sz="2000" dirty="0"/>
                        <a:t>(0.003, 0.17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u="sng" dirty="0"/>
                        <a:t>0.0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597544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3, norm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8, 4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6, 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.49</a:t>
                      </a:r>
                    </a:p>
                    <a:p>
                      <a:pPr algn="ctr"/>
                      <a:r>
                        <a:rPr lang="en-US" sz="2000" dirty="0"/>
                        <a:t>(0.77, 2.88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0.44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2307685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2468481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dirty="0"/>
                        <a:t>Type 4, norm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49, 6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38, 5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.15</a:t>
                      </a:r>
                    </a:p>
                    <a:p>
                      <a:pPr algn="ctr"/>
                      <a:r>
                        <a:rPr lang="en-US" sz="2000" dirty="0"/>
                        <a:t>(0.71, 1.87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0.7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510109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5, mild diarrhe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49, 6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31, 4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u="none" dirty="0"/>
                        <a:t>1.58</a:t>
                      </a:r>
                    </a:p>
                    <a:p>
                      <a:pPr algn="ctr"/>
                      <a:r>
                        <a:rPr lang="en-US" sz="2000" dirty="0"/>
                        <a:t>(1.08, 2.32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u="sng" dirty="0"/>
                        <a:t>0.1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6156445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6, moderate diarrhe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79, 23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116, 16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u="none" dirty="0"/>
                        <a:t>1.55</a:t>
                      </a:r>
                    </a:p>
                    <a:p>
                      <a:pPr algn="ctr"/>
                      <a:r>
                        <a:rPr lang="en-US" sz="2000" dirty="0"/>
                        <a:t>(1.21, 2.00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u="sng" dirty="0"/>
                        <a:t>0.0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826074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Type 7, severe diarrhea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45, 3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/>
                        <a:t>298, 42%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u="none" dirty="0"/>
                        <a:t>0.63</a:t>
                      </a:r>
                    </a:p>
                    <a:p>
                      <a:pPr algn="ctr"/>
                      <a:r>
                        <a:rPr lang="en-US" sz="2000" dirty="0"/>
                        <a:t>(0.44, 0.91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1" u="sng" dirty="0"/>
                        <a:t>0.1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0678415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40538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8</Words>
  <Application>Microsoft Macintosh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rees, Zachary</dc:creator>
  <cp:lastModifiedBy>Crees, Zachary</cp:lastModifiedBy>
  <cp:revision>3</cp:revision>
  <dcterms:created xsi:type="dcterms:W3CDTF">2025-10-24T05:07:41Z</dcterms:created>
  <dcterms:modified xsi:type="dcterms:W3CDTF">2025-10-24T05:14:38Z</dcterms:modified>
</cp:coreProperties>
</file>